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5" r:id="rId2"/>
  </p:sldIdLst>
  <p:sldSz cx="12192000" cy="6858000"/>
  <p:notesSz cx="6802438" cy="99345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98" autoAdjust="0"/>
    <p:restoredTop sz="94921" autoAdjust="0"/>
  </p:normalViewPr>
  <p:slideViewPr>
    <p:cSldViewPr snapToGrid="0">
      <p:cViewPr varScale="1">
        <p:scale>
          <a:sx n="89" d="100"/>
          <a:sy n="89" d="100"/>
        </p:scale>
        <p:origin x="45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4330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8158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99697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8776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6915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1980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3883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2841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6306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29496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794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017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Table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3696763"/>
              </p:ext>
            </p:extLst>
          </p:nvPr>
        </p:nvGraphicFramePr>
        <p:xfrm>
          <a:off x="2298338" y="2273513"/>
          <a:ext cx="7724559" cy="202597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79371"/>
                <a:gridCol w="2459114"/>
                <a:gridCol w="3986074"/>
              </a:tblGrid>
              <a:tr h="337663">
                <a:tc>
                  <a:txBody>
                    <a:bodyPr/>
                    <a:lstStyle/>
                    <a:p>
                      <a:pPr algn="ctr"/>
                      <a:r>
                        <a:rPr lang="en-I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IN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 (5’ – 3’)</a:t>
                      </a:r>
                      <a:endParaRPr lang="en-IN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 (5’ – 3’)</a:t>
                      </a:r>
                      <a:endParaRPr lang="en-IN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7663">
                <a:tc>
                  <a:txBody>
                    <a:bodyPr/>
                    <a:lstStyle/>
                    <a:p>
                      <a:pPr algn="ctr"/>
                      <a:r>
                        <a:rPr lang="en-IN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GACCATCATTGAAGGAATGAG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CCACACTCTTTATGTGTTTTCC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7663">
                <a:tc>
                  <a:txBody>
                    <a:bodyPr/>
                    <a:lstStyle/>
                    <a:p>
                      <a:pPr algn="ctr"/>
                      <a:r>
                        <a:rPr lang="en-IN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</a:t>
                      </a:r>
                      <a:r>
                        <a:rPr lang="el-GR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IN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CATCCAAGAGCGTGAAG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ATCGCAAATCGTGCATT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7663">
                <a:tc>
                  <a:txBody>
                    <a:bodyPr/>
                    <a:lstStyle/>
                    <a:p>
                      <a:pPr algn="ctr"/>
                      <a:r>
                        <a:rPr lang="en-IN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b9a</a:t>
                      </a:r>
                      <a:endParaRPr lang="en-IN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AGGAGTTTGTAGTGAATGCTC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ACTTCTCTTCTGTTCCATCTT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7663">
                <a:tc>
                  <a:txBody>
                    <a:bodyPr/>
                    <a:lstStyle/>
                    <a:p>
                      <a:pPr algn="ctr"/>
                      <a:r>
                        <a:rPr lang="en-IN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8</a:t>
                      </a:r>
                      <a:endParaRPr lang="en-IN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GTCGAGTCGAAACTGAAAC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CTTGCTGTAAGCAGGAAATCT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7663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T-18S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</a:t>
                      </a:r>
                      <a:r>
                        <a:rPr lang="en-IN" sz="10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ATTGCTCCATCTCG</a:t>
                      </a:r>
                      <a:endParaRPr lang="en-IN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ATACGACTCACTATAGGG</a:t>
                      </a:r>
                      <a:r>
                        <a:rPr lang="en-IN" sz="1000" u="none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ATGTCTGCCCTATCAAC</a:t>
                      </a:r>
                      <a:endParaRPr lang="en-IN" sz="1000" u="sng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3376441" y="1846555"/>
            <a:ext cx="5368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. Primer sequences of immune markers and </a:t>
            </a:r>
            <a:r>
              <a:rPr lang="en-IN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I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nscribed RNA.</a:t>
            </a:r>
            <a:endParaRPr lang="en-IN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368951" y="4094405"/>
            <a:ext cx="1698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oter sequence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605178" y="2263809"/>
            <a:ext cx="7270316" cy="20768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292350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54</TotalTime>
  <Words>50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nal results</dc:title>
  <dc:creator>Abhishikta Basu</dc:creator>
  <cp:lastModifiedBy>Abhishikta Basu</cp:lastModifiedBy>
  <cp:revision>1019</cp:revision>
  <cp:lastPrinted>2019-02-25T07:19:18Z</cp:lastPrinted>
  <dcterms:created xsi:type="dcterms:W3CDTF">2018-11-09T05:24:25Z</dcterms:created>
  <dcterms:modified xsi:type="dcterms:W3CDTF">2019-12-23T05:24:32Z</dcterms:modified>
</cp:coreProperties>
</file>